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6858000" cy="9144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83AB7E4-403D-40A7-AC29-335FDD27C7C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CD4778E-D53B-4C02-97DE-B4F340B3D7B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24BA211-4728-48C2-BA49-3EF8D48A540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008F597-3895-4FBC-BB0D-E6B0DF9528D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01684B6-E720-413C-BEAE-B68B6EA9452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2DF338-6F5E-4F1B-9F38-4A6E93E18CE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85FDDB7-AAB0-4D48-8630-3756B782F85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B12B544-555B-48A4-A2FA-8FEFFEE6B02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A7A0C4-43CD-4789-BFE5-AEB6C204BA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2698500-03A6-4602-B105-2F707F66084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01EDC6C-D302-450F-B04E-B867A09A503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DEE7BC-D3E7-48B1-83C7-539EC3AAB66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6A3AB2D-F78C-4554-9598-109C621C0055}" type="datetime">
              <a:rPr b="0" lang="en-US" sz="1200" spc="-1" strike="noStrike">
                <a:solidFill>
                  <a:srgbClr val="898989"/>
                </a:solidFill>
                <a:latin typeface="Calibri"/>
                <a:ea typeface="Arial"/>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E733EB5-A70B-4925-91A6-9E230868A7CA}" type="slidenum">
              <a:rPr b="0" lang="en-US" sz="1200" spc="-1" strike="noStrike">
                <a:solidFill>
                  <a:srgbClr val="898989"/>
                </a:solidFill>
                <a:latin typeface="Calibri"/>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9"/>
          <p:cNvSpPr/>
          <p:nvPr/>
        </p:nvSpPr>
        <p:spPr>
          <a:xfrm>
            <a:off x="333360" y="395280"/>
            <a:ext cx="6191280" cy="428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ry table 1A: </a:t>
            </a:r>
            <a:r>
              <a:rPr b="0" lang="en-US" sz="1100" spc="-1" strike="noStrike">
                <a:solidFill>
                  <a:srgbClr val="000000"/>
                </a:solidFill>
                <a:latin typeface="Times New Roman"/>
                <a:ea typeface="Times New Roman"/>
              </a:rPr>
              <a:t>Description of the studies involved in the BCAC and the percentage of tumors with ANXA1 expression.</a:t>
            </a:r>
            <a:endParaRPr b="0" lang="en-US" sz="1100" spc="-1" strike="noStrike">
              <a:solidFill>
                <a:srgbClr val="000000"/>
              </a:solidFill>
              <a:latin typeface="Arial"/>
            </a:endParaRPr>
          </a:p>
        </p:txBody>
      </p:sp>
      <p:graphicFrame>
        <p:nvGraphicFramePr>
          <p:cNvPr id="42" name=""/>
          <p:cNvGraphicFramePr/>
          <p:nvPr/>
        </p:nvGraphicFramePr>
        <p:xfrm>
          <a:off x="260280" y="900000"/>
          <a:ext cx="6408720" cy="7848720"/>
        </p:xfrm>
        <a:graphic>
          <a:graphicData uri="http://schemas.openxmlformats.org/drawingml/2006/table">
            <a:tbl>
              <a:tblPr/>
              <a:tblGrid>
                <a:gridCol w="933480"/>
                <a:gridCol w="579600"/>
                <a:gridCol w="753840"/>
                <a:gridCol w="900360"/>
                <a:gridCol w="2576520"/>
                <a:gridCol w="664920"/>
              </a:tblGrid>
              <a:tr h="15408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r>
              <a:tr h="32544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Arial"/>
                        </a:rPr>
                        <a:t>Study</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Arial"/>
                        </a:rPr>
                        <a:t>Acronym</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Arial"/>
                        </a:rPr>
                        <a:t>Country</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Arial"/>
                        </a:rPr>
                        <a:t>Study design</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Arial"/>
                        </a:rPr>
                        <a:t>Case definition</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Arial"/>
                        </a:rPr>
                        <a:t>ANXA1+</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r>
              <a:tr h="53028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Amsterdam Breast</a:t>
                      </a:r>
                      <a:br>
                        <a:rPr sz="1000"/>
                      </a:br>
                      <a:r>
                        <a:rPr b="0" lang="en-US" sz="1000" spc="-1" strike="noStrike">
                          <a:solidFill>
                            <a:srgbClr val="000000"/>
                          </a:solidFill>
                          <a:latin typeface="Times New Roman"/>
                          <a:ea typeface="Arial"/>
                        </a:rPr>
                        <a:t>Cancer Study</a:t>
                      </a:r>
                      <a:r>
                        <a:rPr b="0" lang="en-US" sz="1000" spc="-1" strike="noStrike" baseline="30000">
                          <a:solidFill>
                            <a:srgbClr val="000000"/>
                          </a:solidFill>
                          <a:latin typeface="Times New Roman"/>
                          <a:ea typeface="Arial"/>
                        </a:rPr>
                        <a:t>1</a:t>
                      </a:r>
                      <a:endParaRPr b="0" lang="en-US" sz="10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ABCS</a:t>
                      </a:r>
                      <a:endParaRPr b="0" lang="en-US" sz="10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Netherlands</a:t>
                      </a:r>
                      <a:endParaRPr b="0" lang="en-US" sz="10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Hospital-based consecutive cases</a:t>
                      </a:r>
                      <a:endParaRPr b="0" lang="en-US" sz="9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All cases (operable, invasive mammacarcinoma) aged &lt;50 and diagnosed from 1974-1994 in 4 Dutch hospitals.</a:t>
                      </a:r>
                      <a:endParaRPr b="0" lang="en-US" sz="9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12.9%</a:t>
                      </a:r>
                      <a:endParaRPr b="0" lang="en-US" sz="10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r>
              <a:tr h="94608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ESTHER </a:t>
                      </a:r>
                      <a:br>
                        <a:rPr sz="1000"/>
                      </a:br>
                      <a:r>
                        <a:rPr b="0" lang="en-US" sz="1000" spc="-1" strike="noStrike">
                          <a:solidFill>
                            <a:srgbClr val="000000"/>
                          </a:solidFill>
                          <a:latin typeface="Times New Roman"/>
                          <a:ea typeface="Arial"/>
                        </a:rPr>
                        <a:t>Breast Cancer Study</a:t>
                      </a:r>
                      <a:r>
                        <a:rPr b="0" lang="en-US" sz="1000" spc="-1" strike="noStrike" baseline="30000">
                          <a:solidFill>
                            <a:srgbClr val="000000"/>
                          </a:solidFill>
                          <a:latin typeface="Times New Roman"/>
                          <a:ea typeface="Arial"/>
                        </a:rPr>
                        <a:t>2</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ESTHER</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Germany</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Population-based study</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380 women with breast cancer aged 50-75 recruited during their first stay in the hospital. Recruitment and baseline examinations were carried out in 2001-2003.</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14.5%</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119556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Helsinki Breast</a:t>
                      </a:r>
                      <a:br>
                        <a:rPr sz="1000"/>
                      </a:br>
                      <a:r>
                        <a:rPr b="0" lang="en-US" sz="1000" spc="-1" strike="noStrike">
                          <a:solidFill>
                            <a:srgbClr val="000000"/>
                          </a:solidFill>
                          <a:latin typeface="Times New Roman"/>
                          <a:ea typeface="Arial"/>
                        </a:rPr>
                        <a:t>Cancer Study</a:t>
                      </a:r>
                      <a:r>
                        <a:rPr b="0" lang="en-US" sz="1000" spc="-1" strike="noStrike" baseline="30000">
                          <a:solidFill>
                            <a:srgbClr val="000000"/>
                          </a:solidFill>
                          <a:latin typeface="Times New Roman"/>
                          <a:ea typeface="Arial"/>
                        </a:rPr>
                        <a:t>3</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HEBCS</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Finland</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Hospital-based + additional familial case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1) Consecutive cases (883) from the Department of Oncology, Helsinki University Central Hospital 1997-8 and 2000; 2)Consecutive cases (986) from the Department of Surgery, Helsinki University Central Hospital 2001 – 2004; 3) Familial breast cancer patients (536) from the Helsinki University Central Hospital, Departments of Oncology and Clinical Genetics (1995-)</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14.2%</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62064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Kuopio Breast Cancer Project</a:t>
                      </a:r>
                      <a:r>
                        <a:rPr b="0" lang="en-US" sz="1000" spc="-1" strike="noStrike" baseline="30000">
                          <a:solidFill>
                            <a:srgbClr val="000000"/>
                          </a:solidFill>
                          <a:latin typeface="Times New Roman"/>
                          <a:ea typeface="Arial"/>
                        </a:rPr>
                        <a:t>4</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KBCP</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Finland</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Hospital-based</a:t>
                      </a:r>
                      <a:br>
                        <a:rPr sz="900"/>
                      </a:br>
                      <a:r>
                        <a:rPr b="0" lang="en-US" sz="900" spc="-1" strike="noStrike">
                          <a:solidFill>
                            <a:srgbClr val="000000"/>
                          </a:solidFill>
                          <a:latin typeface="Times New Roman"/>
                          <a:ea typeface="Arial"/>
                        </a:rPr>
                        <a:t>prospective clinical</a:t>
                      </a:r>
                      <a:br>
                        <a:rPr sz="900"/>
                      </a:br>
                      <a:r>
                        <a:rPr b="0" lang="en-US" sz="900" spc="-1" strike="noStrike">
                          <a:solidFill>
                            <a:srgbClr val="000000"/>
                          </a:solidFill>
                          <a:latin typeface="Times New Roman"/>
                          <a:ea typeface="Arial"/>
                        </a:rPr>
                        <a:t>cohort</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Women seen at Kuopio University Hospital between 1990 and 1995 because of breast lump, mammographic abnormality, or other breast symptom who were found to have breast cancer.</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11.0%</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123336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Kathleen Cuningham</a:t>
                      </a:r>
                      <a:br>
                        <a:rPr sz="1000"/>
                      </a:br>
                      <a:r>
                        <a:rPr b="0" lang="en-US" sz="1000" spc="-1" strike="noStrike">
                          <a:solidFill>
                            <a:srgbClr val="000000"/>
                          </a:solidFill>
                          <a:latin typeface="Times New Roman"/>
                          <a:ea typeface="Arial"/>
                        </a:rPr>
                        <a:t>Foundation Consortium for Familial Breast Cancer</a:t>
                      </a:r>
                      <a:r>
                        <a:rPr b="0" lang="en-US" sz="1000" spc="-1" strike="noStrike" baseline="30000">
                          <a:solidFill>
                            <a:srgbClr val="000000"/>
                          </a:solidFill>
                          <a:latin typeface="Times New Roman"/>
                          <a:ea typeface="Arial"/>
                        </a:rPr>
                        <a:t>5</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KConFab</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Australia </a:t>
                      </a:r>
                      <a:br>
                        <a:rPr sz="1000"/>
                      </a:br>
                      <a:r>
                        <a:rPr b="0" lang="en-US" sz="1000" spc="-1" strike="noStrike">
                          <a:solidFill>
                            <a:srgbClr val="000000"/>
                          </a:solidFill>
                          <a:latin typeface="Times New Roman"/>
                          <a:ea typeface="Arial"/>
                        </a:rPr>
                        <a:t>&amp; </a:t>
                      </a:r>
                      <a:br>
                        <a:rPr sz="1000"/>
                      </a:br>
                      <a:r>
                        <a:rPr b="0" lang="en-US" sz="1000" spc="-1" strike="noStrike">
                          <a:solidFill>
                            <a:srgbClr val="000000"/>
                          </a:solidFill>
                          <a:latin typeface="Times New Roman"/>
                          <a:ea typeface="Arial"/>
                        </a:rPr>
                        <a:t>New </a:t>
                      </a:r>
                      <a:br>
                        <a:rPr sz="1000"/>
                      </a:br>
                      <a:r>
                        <a:rPr b="0" lang="en-US" sz="1000" spc="-1" strike="noStrike">
                          <a:solidFill>
                            <a:srgbClr val="000000"/>
                          </a:solidFill>
                          <a:latin typeface="Times New Roman"/>
                          <a:ea typeface="Arial"/>
                        </a:rPr>
                        <a:t>Zealand</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Clinic-based recruitment of familial breast cancer patient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Cases were from multiple-case breast and breast-ovarian families recruited though family cancer clinics from across Australia and New Zealand from 1998 to the present. Cases were selected for inclusion in BCAC studies if (i) family was negative for mutations in BRCA1 and BRCA2 (ii) case was the index for the family, defined as youngest breast cancer affected family member.</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17.6%</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47772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Mayo Clinic Breast Cancer Study</a:t>
                      </a:r>
                      <a:r>
                        <a:rPr b="0" lang="en-US" sz="1000" spc="-1" strike="noStrike" baseline="30000">
                          <a:solidFill>
                            <a:srgbClr val="000000"/>
                          </a:solidFill>
                          <a:latin typeface="Times New Roman"/>
                          <a:ea typeface="Arial"/>
                        </a:rPr>
                        <a:t>6</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MCBCS</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USA</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Hospital-based case-control study</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Incident cases residing in 6 states (MN, WI, IA, IL, ND, SD) seen at the Mayo Clinic in Rochester, MN from 2002 to 2010.</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32.2%</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77472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NCI Polish Breast Cancer Study</a:t>
                      </a:r>
                      <a:r>
                        <a:rPr b="0" lang="en-US" sz="1000" spc="-1" strike="noStrike" baseline="30000">
                          <a:solidFill>
                            <a:srgbClr val="000000"/>
                          </a:solidFill>
                          <a:latin typeface="Times New Roman"/>
                          <a:ea typeface="Arial"/>
                        </a:rPr>
                        <a:t>7</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PBCS</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Poland</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Population-based study</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Incident cases from 2000-2003 identified through a rapid identification system in participating hospitals covering ~ 90% of all eligible cases, and cancer registries in Warsaw and Łódź covering 100% of all eligible case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8.1%</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50652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Rotterdam Breast Cancer Study</a:t>
                      </a:r>
                      <a:r>
                        <a:rPr b="0" lang="en-US" sz="1000" spc="-1" strike="noStrike" baseline="30000">
                          <a:solidFill>
                            <a:srgbClr val="000000"/>
                          </a:solidFill>
                          <a:latin typeface="Times New Roman"/>
                          <a:ea typeface="Arial"/>
                        </a:rPr>
                        <a:t>8</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RBCS</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Netherlands</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Hospital based study</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Familial breast cancer patients selected from the clinical genetics center at Erasmus Medical Center; recruited 1994 - 2005</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21.8%</a:t>
                      </a:r>
                      <a:endParaRPr b="0" lang="en-US" sz="10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r>
              <a:tr h="87012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Study of</a:t>
                      </a:r>
                      <a:br>
                        <a:rPr sz="1000"/>
                      </a:br>
                      <a:r>
                        <a:rPr b="0" lang="en-US" sz="1000" spc="-1" strike="noStrike">
                          <a:solidFill>
                            <a:srgbClr val="000000"/>
                          </a:solidFill>
                          <a:latin typeface="Times New Roman"/>
                          <a:ea typeface="Arial"/>
                        </a:rPr>
                        <a:t>Epidemiology and</a:t>
                      </a:r>
                      <a:br>
                        <a:rPr sz="1000"/>
                      </a:br>
                      <a:r>
                        <a:rPr b="0" lang="en-US" sz="1000" spc="-1" strike="noStrike">
                          <a:solidFill>
                            <a:srgbClr val="000000"/>
                          </a:solidFill>
                          <a:latin typeface="Times New Roman"/>
                          <a:ea typeface="Arial"/>
                        </a:rPr>
                        <a:t>Risk factors in</a:t>
                      </a:r>
                      <a:br>
                        <a:rPr sz="1000"/>
                      </a:br>
                      <a:r>
                        <a:rPr b="0" lang="en-US" sz="1000" spc="-1" strike="noStrike">
                          <a:solidFill>
                            <a:srgbClr val="000000"/>
                          </a:solidFill>
                          <a:latin typeface="Times New Roman"/>
                          <a:ea typeface="Arial"/>
                        </a:rPr>
                        <a:t>Cancer Heredity</a:t>
                      </a:r>
                      <a:r>
                        <a:rPr b="0" lang="en-US" sz="1000" spc="-1" strike="noStrike" baseline="30000">
                          <a:solidFill>
                            <a:srgbClr val="000000"/>
                          </a:solidFill>
                          <a:latin typeface="Times New Roman"/>
                          <a:ea typeface="Arial"/>
                        </a:rPr>
                        <a:t>9</a:t>
                      </a:r>
                      <a:endParaRPr b="0" lang="en-US" sz="10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SEARCH</a:t>
                      </a:r>
                      <a:endParaRPr b="0" lang="en-US" sz="10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UK</a:t>
                      </a:r>
                      <a:endParaRPr b="0" lang="en-US" sz="10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Population-based study</a:t>
                      </a:r>
                      <a:endParaRPr b="0" lang="en-US" sz="9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Arial"/>
                        </a:rPr>
                        <a:t>2 groups of cases identified through East Anglian Cancer Registry; 1) prevalent cases diagnosed age &lt;55 from 1991-6 and alive when study started in 1996; 2) incident cases diagnosed age &lt; 70 diagnosed after 1996.</a:t>
                      </a:r>
                      <a:endParaRPr b="0" lang="en-US" sz="9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9.1%</a:t>
                      </a:r>
                      <a:endParaRPr b="0" lang="en-US" sz="10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r>
              <a:tr h="6120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r>
              <a:tr h="15300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w="1224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w="1224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w="1224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w="1224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w="1224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Times New Roman"/>
                          <a:ea typeface="Arial"/>
                        </a:rPr>
                        <a:t> </a:t>
                      </a:r>
                      <a:endParaRPr b="0" lang="en-US" sz="400" spc="-1" strike="noStrike">
                        <a:solidFill>
                          <a:srgbClr val="000000"/>
                        </a:solidFill>
                        <a:latin typeface="Arial"/>
                      </a:endParaRPr>
                    </a:p>
                  </a:txBody>
                  <a:tcPr anchor="ctr">
                    <a:lnL>
                      <a:noFill/>
                    </a:lnL>
                    <a:lnR>
                      <a:noFill/>
                    </a:lnR>
                    <a:lnT w="12240">
                      <a:solidFill>
                        <a:srgbClr val="000000"/>
                      </a:solidFill>
                    </a:lnT>
                    <a:lnB>
                      <a:noFill/>
                    </a:lnB>
                    <a:solidFill>
                      <a:srgbClr val="ffffff"/>
                    </a:solidFill>
                  </a:tcPr>
                </a:tc>
              </a:tr>
            </a:tbl>
          </a:graphicData>
        </a:graphic>
      </p:graphicFrame>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3" name="TextBox 19"/>
          <p:cNvSpPr/>
          <p:nvPr/>
        </p:nvSpPr>
        <p:spPr>
          <a:xfrm>
            <a:off x="189000" y="1130400"/>
            <a:ext cx="6480000" cy="4357800"/>
          </a:xfrm>
          <a:prstGeom prst="rect">
            <a:avLst/>
          </a:prstGeom>
          <a:noFill/>
          <a:ln w="0">
            <a:noFill/>
          </a:ln>
        </p:spPr>
        <p:style>
          <a:lnRef idx="0"/>
          <a:fillRef idx="0"/>
          <a:effectRef idx="0"/>
          <a:fontRef idx="minor"/>
        </p:style>
        <p:txBody>
          <a:bodyPr lIns="90000" rIns="90000" tIns="46800" bIns="46800" anchor="t">
            <a:spAutoFit/>
          </a:bodyPr>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Schmidt MK, Tollenaar RA, de Kemp SR, Broeks A, Cornelisse CJ, Smit VT, Peterse JL, van Leeuwen FE, Van't Veer LJ: </a:t>
            </a:r>
            <a:r>
              <a:rPr b="1" lang="en-US" sz="1000" spc="-1" strike="noStrike">
                <a:solidFill>
                  <a:srgbClr val="000000"/>
                </a:solidFill>
                <a:latin typeface="Times New Roman"/>
                <a:ea typeface="Times New Roman"/>
              </a:rPr>
              <a:t>Breast cancer survival and tumor characteristics in premenopausal women carrying the CHEK2*1100delC germline mutation</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Journal of clinical oncology </a:t>
            </a:r>
            <a:r>
              <a:rPr b="0" lang="en-US" sz="1000" spc="-1" strike="noStrike">
                <a:solidFill>
                  <a:srgbClr val="000000"/>
                </a:solidFill>
                <a:latin typeface="Times New Roman"/>
                <a:ea typeface="Times New Roman"/>
              </a:rPr>
              <a:t>2007, </a:t>
            </a:r>
            <a:r>
              <a:rPr b="1" lang="en-US" sz="1000" spc="-1" strike="noStrike">
                <a:solidFill>
                  <a:srgbClr val="000000"/>
                </a:solidFill>
                <a:latin typeface="Times New Roman"/>
                <a:ea typeface="Times New Roman"/>
              </a:rPr>
              <a:t>25</a:t>
            </a:r>
            <a:r>
              <a:rPr b="0" lang="en-US" sz="1000" spc="-1" strike="noStrike">
                <a:solidFill>
                  <a:srgbClr val="000000"/>
                </a:solidFill>
                <a:latin typeface="Times New Roman"/>
                <a:ea typeface="Times New Roman"/>
              </a:rPr>
              <a:t>(1):64-69.</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Widschwendter M, Apostolidou S, Raum E, Rothenbacher D, Fiegl H, Menon U, Stegmaier C, Jacobs IJ, Brenner H: </a:t>
            </a:r>
            <a:r>
              <a:rPr b="1" lang="en-US" sz="1000" spc="-1" strike="noStrike">
                <a:solidFill>
                  <a:srgbClr val="000000"/>
                </a:solidFill>
                <a:latin typeface="Times New Roman"/>
                <a:ea typeface="Times New Roman"/>
              </a:rPr>
              <a:t>Epigenotyping in peripheral blood cell DNA and breast cancer risk: a proof of principle study</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PloS one </a:t>
            </a:r>
            <a:r>
              <a:rPr b="0" lang="en-US" sz="1000" spc="-1" strike="noStrike">
                <a:solidFill>
                  <a:srgbClr val="000000"/>
                </a:solidFill>
                <a:latin typeface="Times New Roman"/>
                <a:ea typeface="Times New Roman"/>
              </a:rPr>
              <a:t>2008, </a:t>
            </a:r>
            <a:r>
              <a:rPr b="1" lang="en-US" sz="1000" spc="-1" strike="noStrike">
                <a:solidFill>
                  <a:srgbClr val="000000"/>
                </a:solidFill>
                <a:latin typeface="Times New Roman"/>
                <a:ea typeface="Times New Roman"/>
              </a:rPr>
              <a:t>3</a:t>
            </a:r>
            <a:r>
              <a:rPr b="0" lang="en-US" sz="1000" spc="-1" strike="noStrike">
                <a:solidFill>
                  <a:srgbClr val="000000"/>
                </a:solidFill>
                <a:latin typeface="Times New Roman"/>
                <a:ea typeface="Times New Roman"/>
              </a:rPr>
              <a:t>(7):e2656.</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Fagerholm R, Hofstetter B, Tommiska J, Aaltonen K, Vrtel R, Syrjakoski K, Kallioniemi A, Kilpivaara O, Mannermaa A, Kosma VM</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NAD(P)H:quinone oxidoreductase 1 NQO1*2 genotype (P187S) is a strong prognostic and predictive factor in breast cancer</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Nature genetics </a:t>
            </a:r>
            <a:r>
              <a:rPr b="0" lang="en-US" sz="1000" spc="-1" strike="noStrike">
                <a:solidFill>
                  <a:srgbClr val="000000"/>
                </a:solidFill>
                <a:latin typeface="Times New Roman"/>
                <a:ea typeface="Times New Roman"/>
              </a:rPr>
              <a:t>2008, </a:t>
            </a:r>
            <a:r>
              <a:rPr b="1" lang="en-US" sz="1000" spc="-1" strike="noStrike">
                <a:solidFill>
                  <a:srgbClr val="000000"/>
                </a:solidFill>
                <a:latin typeface="Times New Roman"/>
                <a:ea typeface="Times New Roman"/>
              </a:rPr>
              <a:t>40</a:t>
            </a:r>
            <a:r>
              <a:rPr b="0" lang="en-US" sz="1000" spc="-1" strike="noStrike">
                <a:solidFill>
                  <a:srgbClr val="000000"/>
                </a:solidFill>
                <a:latin typeface="Times New Roman"/>
                <a:ea typeface="Times New Roman"/>
              </a:rPr>
              <a:t>(7):844-853.</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Hartikainen JM, Tuhkanen H, Kataja V, Dunning AM, Antoniou A, Smith P, Arffman A, Pirskanen M, Easton DF, Eskelinen M</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An autosome-wide scan for linkage disequilibrium-based association in sporadic breast cancer cases in eastern Finland: three candidate regions found</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Cancer epidemiology, biomarkers &amp; prevention </a:t>
            </a:r>
            <a:r>
              <a:rPr b="0" lang="en-US" sz="1000" spc="-1" strike="noStrike">
                <a:solidFill>
                  <a:srgbClr val="000000"/>
                </a:solidFill>
                <a:latin typeface="Times New Roman"/>
                <a:ea typeface="Times New Roman"/>
              </a:rPr>
              <a:t>2005, </a:t>
            </a:r>
            <a:r>
              <a:rPr b="1" lang="en-US" sz="1000" spc="-1" strike="noStrike">
                <a:solidFill>
                  <a:srgbClr val="000000"/>
                </a:solidFill>
                <a:latin typeface="Times New Roman"/>
                <a:ea typeface="Times New Roman"/>
              </a:rPr>
              <a:t>14</a:t>
            </a:r>
            <a:r>
              <a:rPr b="0" lang="en-US" sz="1000" spc="-1" strike="noStrike">
                <a:solidFill>
                  <a:srgbClr val="000000"/>
                </a:solidFill>
                <a:latin typeface="Times New Roman"/>
                <a:ea typeface="Times New Roman"/>
              </a:rPr>
              <a:t>(1):75-80.</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Mann GJ, Thorne H, Balleine RL, Butow PN, Clarke CL, Edkins E, Evans GM, Fereday S, Haan E, Gattas M</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Analysis of cancer risk and BRCA1 and BRCA2 mutation prevalence in the kConFab familial breast cancer resource</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Breast cancer research : BCR </a:t>
            </a:r>
            <a:r>
              <a:rPr b="0" lang="en-US" sz="1000" spc="-1" strike="noStrike">
                <a:solidFill>
                  <a:srgbClr val="000000"/>
                </a:solidFill>
                <a:latin typeface="Times New Roman"/>
                <a:ea typeface="Times New Roman"/>
              </a:rPr>
              <a:t>2006, </a:t>
            </a:r>
            <a:r>
              <a:rPr b="1" lang="en-US" sz="1000" spc="-1" strike="noStrike">
                <a:solidFill>
                  <a:srgbClr val="000000"/>
                </a:solidFill>
                <a:latin typeface="Times New Roman"/>
                <a:ea typeface="Times New Roman"/>
              </a:rPr>
              <a:t>8</a:t>
            </a:r>
            <a:r>
              <a:rPr b="0" lang="en-US" sz="1000" spc="-1" strike="noStrike">
                <a:solidFill>
                  <a:srgbClr val="000000"/>
                </a:solidFill>
                <a:latin typeface="Times New Roman"/>
                <a:ea typeface="Times New Roman"/>
              </a:rPr>
              <a:t>(1):R12.</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Olson JE, Ingle JN, Ma CX, Pelleymounter LL, Schaid DJ, Pankratz VS, Vierkant RA, Fredericksen ZS, Wu Y, Couch FJ</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A comprehensive examination of CYP19 variation and risk of breast cancer using two haplotype-tagging approaches</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Breast cancer research and treatment </a:t>
            </a:r>
            <a:r>
              <a:rPr b="0" lang="en-US" sz="1000" spc="-1" strike="noStrike">
                <a:solidFill>
                  <a:srgbClr val="000000"/>
                </a:solidFill>
                <a:latin typeface="Times New Roman"/>
                <a:ea typeface="Times New Roman"/>
              </a:rPr>
              <a:t>2007, </a:t>
            </a:r>
            <a:r>
              <a:rPr b="1" lang="en-US" sz="1000" spc="-1" strike="noStrike">
                <a:solidFill>
                  <a:srgbClr val="000000"/>
                </a:solidFill>
                <a:latin typeface="Times New Roman"/>
                <a:ea typeface="Times New Roman"/>
              </a:rPr>
              <a:t>102</a:t>
            </a:r>
            <a:r>
              <a:rPr b="0" lang="en-US" sz="1000" spc="-1" strike="noStrike">
                <a:solidFill>
                  <a:srgbClr val="000000"/>
                </a:solidFill>
                <a:latin typeface="Times New Roman"/>
                <a:ea typeface="Times New Roman"/>
              </a:rPr>
              <a:t>(2):237-247.</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Gaudet MM, Hunter K, Pharoah P, Dunning AM, Driver K, Lissowska J, Sherman M, Peplonska B, Brinton LA, Chanock S</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Genetic variation in SIPA1 in relation to breast cancer risk and survival after breast cancer diagnosis</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International journal of cancer Journal </a:t>
            </a:r>
            <a:r>
              <a:rPr b="0" lang="en-US" sz="1000" spc="-1" strike="noStrike">
                <a:solidFill>
                  <a:srgbClr val="000000"/>
                </a:solidFill>
                <a:latin typeface="Times New Roman"/>
                <a:ea typeface="Times New Roman"/>
              </a:rPr>
              <a:t>2009, </a:t>
            </a:r>
            <a:r>
              <a:rPr b="1" lang="en-US" sz="1000" spc="-1" strike="noStrike">
                <a:solidFill>
                  <a:srgbClr val="000000"/>
                </a:solidFill>
                <a:latin typeface="Times New Roman"/>
                <a:ea typeface="Times New Roman"/>
              </a:rPr>
              <a:t>124</a:t>
            </a:r>
            <a:r>
              <a:rPr b="0" lang="en-US" sz="1000" spc="-1" strike="noStrike">
                <a:solidFill>
                  <a:srgbClr val="000000"/>
                </a:solidFill>
                <a:latin typeface="Times New Roman"/>
                <a:ea typeface="Times New Roman"/>
              </a:rPr>
              <a:t>(7):1716-1720.</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Easton DF, Pooley KA, Dunning AM, Pharoah PD, Thompson D, Ballinger DG, Struewing JP, Morrison J, Field H, Luben R</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Genome-wide association study identifies novel breast cancer susceptibility loci</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Nature </a:t>
            </a:r>
            <a:r>
              <a:rPr b="0" lang="en-US" sz="1000" spc="-1" strike="noStrike">
                <a:solidFill>
                  <a:srgbClr val="000000"/>
                </a:solidFill>
                <a:latin typeface="Times New Roman"/>
                <a:ea typeface="Times New Roman"/>
              </a:rPr>
              <a:t>2007, </a:t>
            </a:r>
            <a:r>
              <a:rPr b="1" lang="en-US" sz="1000" spc="-1" strike="noStrike">
                <a:solidFill>
                  <a:srgbClr val="000000"/>
                </a:solidFill>
                <a:latin typeface="Times New Roman"/>
                <a:ea typeface="Times New Roman"/>
              </a:rPr>
              <a:t>447</a:t>
            </a:r>
            <a:r>
              <a:rPr b="0" lang="en-US" sz="1000" spc="-1" strike="noStrike">
                <a:solidFill>
                  <a:srgbClr val="000000"/>
                </a:solidFill>
                <a:latin typeface="Times New Roman"/>
                <a:ea typeface="Times New Roman"/>
              </a:rPr>
              <a:t>(7148):1087-1093.</a:t>
            </a:r>
            <a:endParaRPr b="0" lang="en-US" sz="1000" spc="-1" strike="noStrike">
              <a:solidFill>
                <a:srgbClr val="000000"/>
              </a:solidFill>
              <a:latin typeface="Arial"/>
            </a:endParaRPr>
          </a:p>
          <a:p>
            <a:pPr marL="228600" indent="-228600" algn="just">
              <a:lnSpc>
                <a:spcPct val="100000"/>
              </a:lnSpc>
              <a:buClr>
                <a:srgbClr val="0000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zzato EM, Tyrer J, Fasching PA, Beckmann MW, Ekici AB, Schulz-Wendtland R, Bojesen SE, Nordestgaard BG, Flyger H, Milne RL</a:t>
            </a:r>
            <a:r>
              <a:rPr b="0" i="1" lang="en-US" sz="1000" spc="-1" strike="noStrike">
                <a:solidFill>
                  <a:srgbClr val="000000"/>
                </a:solidFill>
                <a:latin typeface="Times New Roman"/>
                <a:ea typeface="Times New Roman"/>
              </a:rPr>
              <a:t> et al</a:t>
            </a:r>
            <a:r>
              <a:rPr b="0"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Association between a germline OCA2 polymorphism at chromosome 15q13.1 and estrogen receptor-negative breast cancer survival</a:t>
            </a: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Journal of the national cancer institute </a:t>
            </a:r>
            <a:r>
              <a:rPr b="0" lang="en-US" sz="1000" spc="-1" strike="noStrike">
                <a:solidFill>
                  <a:srgbClr val="000000"/>
                </a:solidFill>
                <a:latin typeface="Times New Roman"/>
                <a:ea typeface="Times New Roman"/>
              </a:rPr>
              <a:t>2010, </a:t>
            </a:r>
            <a:r>
              <a:rPr b="1" lang="en-US" sz="1000" spc="-1" strike="noStrike">
                <a:solidFill>
                  <a:srgbClr val="000000"/>
                </a:solidFill>
                <a:latin typeface="Times New Roman"/>
                <a:ea typeface="Times New Roman"/>
              </a:rPr>
              <a:t>102</a:t>
            </a:r>
            <a:r>
              <a:rPr b="0" lang="en-US" sz="1000" spc="-1" strike="noStrike">
                <a:solidFill>
                  <a:srgbClr val="000000"/>
                </a:solidFill>
                <a:latin typeface="Times New Roman"/>
                <a:ea typeface="Times New Roman"/>
              </a:rPr>
              <a:t>(9):650-662.</a:t>
            </a:r>
            <a:endParaRPr b="0" lang="en-US" sz="1000" spc="-1" strike="noStrike">
              <a:solidFill>
                <a:srgbClr val="000000"/>
              </a:solidFill>
              <a:latin typeface="Arial"/>
            </a:endParaRPr>
          </a:p>
        </p:txBody>
      </p:sp>
      <p:sp>
        <p:nvSpPr>
          <p:cNvPr id="44" name="TextBox 19"/>
          <p:cNvSpPr/>
          <p:nvPr/>
        </p:nvSpPr>
        <p:spPr>
          <a:xfrm>
            <a:off x="208080" y="746280"/>
            <a:ext cx="604836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References for supplementary table 1A:</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 name="TextBox 19"/>
          <p:cNvSpPr/>
          <p:nvPr/>
        </p:nvSpPr>
        <p:spPr>
          <a:xfrm>
            <a:off x="260280" y="709560"/>
            <a:ext cx="619308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ry table 1B: </a:t>
            </a:r>
            <a:r>
              <a:rPr b="0" lang="en-US" sz="1100" spc="-1" strike="noStrike">
                <a:solidFill>
                  <a:srgbClr val="000000"/>
                </a:solidFill>
                <a:latin typeface="Times New Roman"/>
                <a:ea typeface="Times New Roman"/>
              </a:rPr>
              <a:t>Full list of ethics committees that approved the studies included.</a:t>
            </a:r>
            <a:endParaRPr b="0" lang="en-US" sz="1100" spc="-1" strike="noStrike">
              <a:solidFill>
                <a:srgbClr val="000000"/>
              </a:solidFill>
              <a:latin typeface="Arial"/>
            </a:endParaRPr>
          </a:p>
        </p:txBody>
      </p:sp>
      <p:graphicFrame>
        <p:nvGraphicFramePr>
          <p:cNvPr id="46" name=""/>
          <p:cNvGraphicFramePr/>
          <p:nvPr/>
        </p:nvGraphicFramePr>
        <p:xfrm>
          <a:off x="352440" y="1116000"/>
          <a:ext cx="5956200" cy="3306600"/>
        </p:xfrm>
        <a:graphic>
          <a:graphicData uri="http://schemas.openxmlformats.org/drawingml/2006/table">
            <a:tbl>
              <a:tblPr/>
              <a:tblGrid>
                <a:gridCol w="1260360"/>
                <a:gridCol w="1030320"/>
                <a:gridCol w="3665520"/>
              </a:tblGrid>
              <a:tr h="15264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Study Acronym</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Country</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Local name of Ethics Committee</a:t>
                      </a:r>
                      <a:endParaRPr b="0" lang="en-US" sz="1000" spc="-1" strike="noStrike">
                        <a:solidFill>
                          <a:srgbClr val="000000"/>
                        </a:solidFill>
                        <a:latin typeface="Arial"/>
                      </a:endParaRPr>
                    </a:p>
                  </a:txBody>
                  <a:tcPr anchor="ctr">
                    <a:lnL>
                      <a:noFill/>
                    </a:lnL>
                    <a:lnR>
                      <a:noFill/>
                    </a:lnR>
                    <a:lnT w="12240">
                      <a:solidFill>
                        <a:srgbClr val="000000"/>
                      </a:solidFill>
                    </a:lnT>
                    <a:lnB w="12240">
                      <a:solidFill>
                        <a:srgbClr val="000000"/>
                      </a:solidFill>
                    </a:lnB>
                    <a:solidFill>
                      <a:srgbClr val="ffffff"/>
                    </a:solidFill>
                  </a:tcPr>
                </a:tc>
              </a:tr>
              <a:tr h="54864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ABCS</a:t>
                      </a:r>
                      <a:endParaRPr b="0" lang="en-US" sz="9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Netherlands</a:t>
                      </a:r>
                      <a:endParaRPr b="0" lang="en-US" sz="900" spc="-1" strike="noStrike">
                        <a:solidFill>
                          <a:srgbClr val="000000"/>
                        </a:solidFill>
                        <a:latin typeface="Arial"/>
                      </a:endParaRPr>
                    </a:p>
                  </a:txBody>
                  <a:tcPr anchor="ctr">
                    <a:lnL>
                      <a:noFill/>
                    </a:lnL>
                    <a:lnR>
                      <a:noFill/>
                    </a:lnR>
                    <a:lnT w="1224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Times New Roman"/>
                          <a:ea typeface="Times New Roman"/>
                        </a:rPr>
                        <a:t>Leiden University Medical Center (LUMC) Commissie Medische Ethiek; and</a:t>
                      </a:r>
                      <a:endParaRPr b="0" lang="en-US" sz="9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Times New Roman"/>
                          <a:ea typeface="Times New Roman"/>
                        </a:rPr>
                        <a:t>Protocol Toetsingscommissie van het Nederlands Kanker Instituut/Antoni van Leeuwenhoek Ziekenhuis</a:t>
                      </a:r>
                      <a:endParaRPr b="0" lang="en-US" sz="900" spc="-1" strike="noStrike">
                        <a:solidFill>
                          <a:srgbClr val="000000"/>
                        </a:solidFill>
                        <a:latin typeface="Arial"/>
                      </a:endParaRPr>
                    </a:p>
                  </a:txBody>
                  <a:tcPr anchor="ctr">
                    <a:lnL>
                      <a:noFill/>
                    </a:lnL>
                    <a:lnR w="5760">
                      <a:solidFill>
                        <a:srgbClr val="ffffff"/>
                      </a:solidFill>
                    </a:lnR>
                    <a:lnT w="12240">
                      <a:solidFill>
                        <a:srgbClr val="000000"/>
                      </a:solidFill>
                    </a:lnT>
                    <a:lnB w="2880">
                      <a:solidFill>
                        <a:srgbClr val="000000"/>
                      </a:solidFill>
                    </a:lnB>
                    <a:solidFill>
                      <a:srgbClr val="ffffff"/>
                    </a:solidFill>
                  </a:tcPr>
                </a:tc>
              </a:tr>
              <a:tr h="27468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ESTHER</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Germany</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900" spc="-1" strike="noStrike">
                          <a:solidFill>
                            <a:srgbClr val="000000"/>
                          </a:solidFill>
                          <a:latin typeface="Times New Roman"/>
                          <a:ea typeface="Times New Roman"/>
                        </a:rPr>
                        <a:t>Ruprecht-Karls-Universitat Medizinische Fakultat Heidelberg Ethikkommission</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41220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HEBC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Finland</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i-FI" sz="900" spc="-1" strike="noStrike">
                          <a:solidFill>
                            <a:srgbClr val="000000"/>
                          </a:solidFill>
                          <a:latin typeface="Times New Roman"/>
                          <a:ea typeface="Times New Roman"/>
                        </a:rPr>
                        <a:t>Helsingin ja uudenmaan sairaanhoitopiiri (Helsinki University Central Hospital Ethics Committee)</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27288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KBCP</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Finland</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i-FI" sz="900" spc="-1" strike="noStrike">
                          <a:solidFill>
                            <a:srgbClr val="000000"/>
                          </a:solidFill>
                          <a:latin typeface="Times New Roman"/>
                          <a:ea typeface="Times New Roman"/>
                        </a:rPr>
                        <a:t>Pohjois-Savon Sairraanhoitopiirin Kuntayhtyma Tutkimuseettinen Toimikunta</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410760">
                <a:tc rowSpan="2">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kConFab/AOC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rowSpan="2">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Australia </a:t>
                      </a:r>
                      <a:br>
                        <a:rPr sz="900"/>
                      </a:br>
                      <a:r>
                        <a:rPr b="0" lang="en-GB" sz="900" spc="-1" strike="noStrike">
                          <a:solidFill>
                            <a:srgbClr val="000000"/>
                          </a:solidFill>
                          <a:latin typeface="Times New Roman"/>
                          <a:ea typeface="Times New Roman"/>
                        </a:rPr>
                        <a:t>&amp; </a:t>
                      </a:r>
                      <a:br>
                        <a:rPr sz="900"/>
                      </a:br>
                      <a:r>
                        <a:rPr b="0" lang="en-GB" sz="900" spc="-1" strike="noStrike">
                          <a:solidFill>
                            <a:srgbClr val="000000"/>
                          </a:solidFill>
                          <a:latin typeface="Times New Roman"/>
                          <a:ea typeface="Times New Roman"/>
                        </a:rPr>
                        <a:t>New </a:t>
                      </a:r>
                      <a:br>
                        <a:rPr sz="900"/>
                      </a:br>
                      <a:r>
                        <a:rPr b="0" lang="en-GB" sz="900" spc="-1" strike="noStrike">
                          <a:solidFill>
                            <a:srgbClr val="000000"/>
                          </a:solidFill>
                          <a:latin typeface="Times New Roman"/>
                          <a:ea typeface="Times New Roman"/>
                        </a:rPr>
                        <a:t>Zealand</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kConFab: The Queenland Institute of Medical Research Human Research Ethics Committee (QIMR-HREC)</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2743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AOCS: Peter MacCallum Cancer Centre Ethics Committee</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13788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MCBC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USA</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Mayo Clinic IRB</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1375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PBC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Poland</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National Institute of Health (NIH) IRB</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2743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RBC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Netherlands</a:t>
                      </a:r>
                      <a:endParaRPr b="0" lang="en-US" sz="900" spc="-1" strike="noStrike">
                        <a:solidFill>
                          <a:srgbClr val="000000"/>
                        </a:solidFill>
                        <a:latin typeface="Arial"/>
                      </a:endParaRPr>
                    </a:p>
                  </a:txBody>
                  <a:tcPr anchor="ctr">
                    <a:lnL>
                      <a:noFill/>
                    </a:lnL>
                    <a:lnR>
                      <a:noFill/>
                    </a:lnR>
                    <a:lnT w="2880">
                      <a:solidFill>
                        <a:srgbClr val="000000"/>
                      </a:solidFill>
                    </a:lnT>
                    <a:lnB w="288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Medische Ethische Toetsings Commissie Erasmus Medisch Centrum</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w="2880">
                      <a:solidFill>
                        <a:srgbClr val="000000"/>
                      </a:solidFill>
                    </a:lnB>
                    <a:solidFill>
                      <a:srgbClr val="ffffff"/>
                    </a:solidFill>
                  </a:tcPr>
                </a:tc>
              </a:tr>
              <a:tr h="2743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SEARCH</a:t>
                      </a:r>
                      <a:endParaRPr b="0" lang="en-US" sz="9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UK</a:t>
                      </a:r>
                      <a:endParaRPr b="0" lang="en-US" sz="900" spc="-1" strike="noStrike">
                        <a:solidFill>
                          <a:srgbClr val="000000"/>
                        </a:solidFill>
                        <a:latin typeface="Arial"/>
                      </a:endParaRPr>
                    </a:p>
                  </a:txBody>
                  <a:tcPr anchor="ctr">
                    <a:lnL>
                      <a:noFill/>
                    </a:lnL>
                    <a:lnR>
                      <a:noFill/>
                    </a:lnR>
                    <a:lnT w="2880">
                      <a:solidFill>
                        <a:srgbClr val="000000"/>
                      </a:solidFill>
                    </a:lnT>
                    <a:lnB>
                      <a:no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Multi Centre Research Ethics Committee (MREC)</a:t>
                      </a:r>
                      <a:endParaRPr b="0" lang="en-US" sz="900" spc="-1" strike="noStrike">
                        <a:solidFill>
                          <a:srgbClr val="000000"/>
                        </a:solidFill>
                        <a:latin typeface="Arial"/>
                      </a:endParaRPr>
                    </a:p>
                  </a:txBody>
                  <a:tcPr anchor="ctr">
                    <a:lnL>
                      <a:noFill/>
                    </a:lnL>
                    <a:lnR w="5760">
                      <a:solidFill>
                        <a:srgbClr val="ffffff"/>
                      </a:solidFill>
                    </a:lnR>
                    <a:lnT w="2880">
                      <a:solidFill>
                        <a:srgbClr val="000000"/>
                      </a:solidFill>
                    </a:lnT>
                    <a:lnB>
                      <a:noFill/>
                    </a:lnB>
                    <a:solidFill>
                      <a:srgbClr val="ffffff"/>
                    </a:solidFill>
                  </a:tcPr>
                </a:tc>
              </a:tr>
              <a:tr h="1375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 </a:t>
                      </a:r>
                      <a:endParaRPr b="0" lang="en-US" sz="9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 </a:t>
                      </a:r>
                      <a:endParaRPr b="0" lang="en-US" sz="9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Times New Roman"/>
                          <a:ea typeface="Times New Roman"/>
                        </a:rPr>
                        <a:t> </a:t>
                      </a:r>
                      <a:endParaRPr b="0" lang="en-US" sz="900" spc="-1" strike="noStrike">
                        <a:solidFill>
                          <a:srgbClr val="000000"/>
                        </a:solidFill>
                        <a:latin typeface="Arial"/>
                      </a:endParaRPr>
                    </a:p>
                  </a:txBody>
                  <a:tcPr anchor="ctr">
                    <a:lnL>
                      <a:noFill/>
                    </a:lnL>
                    <a:lnR>
                      <a:noFill/>
                    </a:lnR>
                    <a:lnT>
                      <a:noFill/>
                    </a:lnT>
                    <a:lnB w="12240">
                      <a:solidFill>
                        <a:srgbClr val="000000"/>
                      </a:solidFill>
                    </a:lnB>
                    <a:solidFill>
                      <a:srgbClr val="ffffff"/>
                    </a:solid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06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1-01T11:57:37Z</dcterms:created>
  <dc:creator>Marcelo Sobral Leite</dc:creator>
  <dc:description/>
  <dc:language>en-US</dc:language>
  <cp:lastModifiedBy>Marcelo Sobral-Leite</cp:lastModifiedBy>
  <cp:lastPrinted>2014-09-08T08:30:29Z</cp:lastPrinted>
  <dcterms:modified xsi:type="dcterms:W3CDTF">2015-06-02T09:23:25Z</dcterms:modified>
  <cp:revision>418</cp:revision>
  <dc:subject/>
  <dc:title>Slide 1</dc:title>
</cp:coreProperties>
</file>